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6" d="100"/>
          <a:sy n="76" d="100"/>
        </p:scale>
        <p:origin x="31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9" d="100"/>
        <a:sy n="6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ng-Chan Lin" userId="920227259ee68703" providerId="LiveId" clId="{5E96CD85-2C98-4D56-B80A-25A5D609317F}"/>
    <pc:docChg chg="modSld">
      <pc:chgData name="Peng-Chan Lin" userId="920227259ee68703" providerId="LiveId" clId="{5E96CD85-2C98-4D56-B80A-25A5D609317F}" dt="2022-02-01T08:17:18.250" v="5" actId="20577"/>
      <pc:docMkLst>
        <pc:docMk/>
      </pc:docMkLst>
      <pc:sldChg chg="modSp mod">
        <pc:chgData name="Peng-Chan Lin" userId="920227259ee68703" providerId="LiveId" clId="{5E96CD85-2C98-4D56-B80A-25A5D609317F}" dt="2022-02-01T08:17:18.250" v="5" actId="20577"/>
        <pc:sldMkLst>
          <pc:docMk/>
          <pc:sldMk cId="261044915" sldId="263"/>
        </pc:sldMkLst>
        <pc:spChg chg="mod">
          <ac:chgData name="Peng-Chan Lin" userId="920227259ee68703" providerId="LiveId" clId="{5E96CD85-2C98-4D56-B80A-25A5D609317F}" dt="2022-02-01T08:17:13.001" v="2" actId="20577"/>
          <ac:spMkLst>
            <pc:docMk/>
            <pc:sldMk cId="261044915" sldId="263"/>
            <ac:spMk id="6" creationId="{00000000-0000-0000-0000-000000000000}"/>
          </ac:spMkLst>
        </pc:spChg>
        <pc:spChg chg="mod">
          <ac:chgData name="Peng-Chan Lin" userId="920227259ee68703" providerId="LiveId" clId="{5E96CD85-2C98-4D56-B80A-25A5D609317F}" dt="2022-02-01T08:17:18.250" v="5" actId="20577"/>
          <ac:spMkLst>
            <pc:docMk/>
            <pc:sldMk cId="261044915" sldId="263"/>
            <ac:spMk id="7" creationId="{00000000-0000-0000-0000-000000000000}"/>
          </ac:spMkLst>
        </pc:spChg>
      </pc:sldChg>
    </pc:docChg>
  </pc:docChgLst>
  <pc:docChgLst>
    <pc:chgData userId="920227259ee68703" providerId="LiveId" clId="{8A222FF6-9A8B-40D3-9D1E-810C51325FFF}"/>
    <pc:docChg chg="modSld">
      <pc:chgData name="" userId="920227259ee68703" providerId="LiveId" clId="{8A222FF6-9A8B-40D3-9D1E-810C51325FFF}" dt="2021-05-20T04:25:58.895" v="5" actId="20577"/>
      <pc:docMkLst>
        <pc:docMk/>
      </pc:docMkLst>
      <pc:sldChg chg="modSp">
        <pc:chgData name="" userId="920227259ee68703" providerId="LiveId" clId="{8A222FF6-9A8B-40D3-9D1E-810C51325FFF}" dt="2021-05-20T04:25:58.895" v="5" actId="20577"/>
        <pc:sldMkLst>
          <pc:docMk/>
          <pc:sldMk cId="261044915" sldId="263"/>
        </pc:sldMkLst>
        <pc:spChg chg="mod">
          <ac:chgData name="" userId="920227259ee68703" providerId="LiveId" clId="{8A222FF6-9A8B-40D3-9D1E-810C51325FFF}" dt="2021-05-20T04:25:54.971" v="3" actId="20577"/>
          <ac:spMkLst>
            <pc:docMk/>
            <pc:sldMk cId="261044915" sldId="263"/>
            <ac:spMk id="6" creationId="{00000000-0000-0000-0000-000000000000}"/>
          </ac:spMkLst>
        </pc:spChg>
        <pc:spChg chg="mod">
          <ac:chgData name="" userId="920227259ee68703" providerId="LiveId" clId="{8A222FF6-9A8B-40D3-9D1E-810C51325FFF}" dt="2021-05-20T04:25:58.895" v="5" actId="20577"/>
          <ac:spMkLst>
            <pc:docMk/>
            <pc:sldMk cId="261044915" sldId="263"/>
            <ac:spMk id="7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5974E7-C34E-4F12-A3DD-2311DEFD1855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A53B8D-97DF-4B1F-AA26-97355818924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0180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A53B8D-97DF-4B1F-AA26-973558189247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713601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87391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0932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7348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52100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00174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15636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29688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87934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88181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92751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42386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959EA-450E-47B3-B70B-EFD0341713CD}" type="datetimeFigureOut">
              <a:rPr lang="zh-TW" altLang="en-US" smtClean="0"/>
              <a:t>2022/12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87FD0-D7A3-4424-A552-BE7891291DB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26659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316"/>
          <a:stretch/>
        </p:blipFill>
        <p:spPr>
          <a:xfrm>
            <a:off x="488043" y="122179"/>
            <a:ext cx="5976461" cy="3991450"/>
          </a:xfrm>
          <a:prstGeom prst="rect">
            <a:avLst/>
          </a:prstGeom>
        </p:spPr>
      </p:pic>
      <p:sp>
        <p:nvSpPr>
          <p:cNvPr id="6" name="文字方塊 5"/>
          <p:cNvSpPr txBox="1"/>
          <p:nvPr/>
        </p:nvSpPr>
        <p:spPr>
          <a:xfrm>
            <a:off x="-13443" y="20620"/>
            <a:ext cx="61436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96"/>
          <a:stretch/>
        </p:blipFill>
        <p:spPr>
          <a:xfrm>
            <a:off x="365429" y="4211874"/>
            <a:ext cx="6018487" cy="3995121"/>
          </a:xfrm>
          <a:prstGeom prst="rect">
            <a:avLst/>
          </a:prstGeom>
        </p:spPr>
      </p:pic>
      <p:sp>
        <p:nvSpPr>
          <p:cNvPr id="7" name="文字方塊 6"/>
          <p:cNvSpPr txBox="1"/>
          <p:nvPr/>
        </p:nvSpPr>
        <p:spPr>
          <a:xfrm>
            <a:off x="-81167" y="4117471"/>
            <a:ext cx="61436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CD307B9-6ED1-33C8-AA0D-5BCE1E0B7534}"/>
              </a:ext>
            </a:extLst>
          </p:cNvPr>
          <p:cNvSpPr txBox="1"/>
          <p:nvPr/>
        </p:nvSpPr>
        <p:spPr>
          <a:xfrm>
            <a:off x="88900" y="8341322"/>
            <a:ext cx="676909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lang="en-US" altLang="zh-TW" sz="1400" b="1" dirty="0">
                <a:latin typeface="Arial" panose="020B0604020202020204" pitchFamily="34" charset="0"/>
                <a:cs typeface="Arial" panose="020B0604020202020204" pitchFamily="34" charset="0"/>
              </a:rPr>
              <a:t>. 2.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Effect on pain relief score and quality of analgesic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.</a:t>
            </a:r>
            <a:r>
              <a:rPr lang="zh-TW" alt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five-item pain relief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core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as assessed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, Day 2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Day 3.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The results showed no significant difference in the median of the three-day pain relief score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TW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value = 0.79). </a:t>
            </a:r>
            <a:r>
              <a:rPr lang="en-US" altLang="zh-TW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 a five-item quality of analgesic treatment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as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assessed on Day 1, Day 2 and  Day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. The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results showed no significant difference in the median of the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ree-day (</a:t>
            </a:r>
            <a:r>
              <a:rPr lang="en-US" altLang="zh-TW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value 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77).. 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044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5</TotalTime>
  <Words>97</Words>
  <Application>Microsoft Office PowerPoint</Application>
  <PresentationFormat>A4 紙張 (210x297 公釐)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engchanlin</dc:creator>
  <cp:lastModifiedBy>user</cp:lastModifiedBy>
  <cp:revision>44</cp:revision>
  <dcterms:created xsi:type="dcterms:W3CDTF">2020-09-17T15:46:52Z</dcterms:created>
  <dcterms:modified xsi:type="dcterms:W3CDTF">2022-12-10T00:52:16Z</dcterms:modified>
</cp:coreProperties>
</file>